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65"/>
  </p:normalViewPr>
  <p:slideViewPr>
    <p:cSldViewPr snapToGrid="0">
      <p:cViewPr varScale="1">
        <p:scale>
          <a:sx n="89" d="100"/>
          <a:sy n="89" d="100"/>
        </p:scale>
        <p:origin x="89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8C79F52-72EB-FDDB-A613-98E090BB63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A6C96C99-F552-8423-C732-8AEE097869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F0398CE-4338-99AB-F8CA-6B36B9E400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5491B1-C4A9-9F47-98C2-F05075F88C86}" type="datetimeFigureOut">
              <a:rPr lang="de-DE" smtClean="0"/>
              <a:t>09.08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1BB09E9-0E17-D662-A966-A76B95A3AD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29D7842-1F8F-3A09-7A68-2C843904F1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B8393-E09B-8148-A1F6-08E0FC6F3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3276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1C84B4A-702B-3B6A-3DA9-847DC954E1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5E82D2B-A9EB-B749-13B9-7A4673D75F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3BC9F27-3059-3EAA-2AE7-403B5269DB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5491B1-C4A9-9F47-98C2-F05075F88C86}" type="datetimeFigureOut">
              <a:rPr lang="de-DE" smtClean="0"/>
              <a:t>09.08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5DAF481-5654-2AAE-1974-676A961A3F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F862370-696A-2D59-2184-A4A391D62D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B8393-E09B-8148-A1F6-08E0FC6F3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28523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6DA2DD14-2B14-16A1-35F0-C19D73B84E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42470E2-1EE1-4DFD-C28F-1E1F3B5907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2B3061D-2E02-E8F5-D74B-0F7411A1F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5491B1-C4A9-9F47-98C2-F05075F88C86}" type="datetimeFigureOut">
              <a:rPr lang="de-DE" smtClean="0"/>
              <a:t>09.08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6437A5B-0702-C77C-9A24-C6F46545D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E679697-2D97-9BAD-0DEB-D1445A13B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B8393-E09B-8148-A1F6-08E0FC6F3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38394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E05D6A8-7A06-BD20-92E5-2A6B3B3CDA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BCE3FAC-9E81-0086-3494-E3788B0BD9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6FE8C59-8D3B-06CB-EA92-68B6E8517E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5491B1-C4A9-9F47-98C2-F05075F88C86}" type="datetimeFigureOut">
              <a:rPr lang="de-DE" smtClean="0"/>
              <a:t>09.08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DA18DFB-AC31-0885-8429-A4C95E6689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D75AD91-17EB-3AEC-A112-214E6CF229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B8393-E09B-8148-A1F6-08E0FC6F3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759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A8347F3-8CDE-54EE-D964-00B79F9AEE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D25CC5A-9570-88B1-0FD1-158F059EA3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AD05ACB-08BC-2BC1-D26D-8425674334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5491B1-C4A9-9F47-98C2-F05075F88C86}" type="datetimeFigureOut">
              <a:rPr lang="de-DE" smtClean="0"/>
              <a:t>09.08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99229C1-851C-1DC4-72A4-0018AE32E5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D5891D7-7D70-92E2-B8AF-D3D18902C8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B8393-E09B-8148-A1F6-08E0FC6F3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8872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2ECC2E7-6345-18E2-76AD-971558A660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AE6A5B5-DB1B-F040-A3F9-172F8DF191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E22F1886-8F3F-1616-E13C-8812CA775B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2688CC3-3574-87CB-0C8E-340556A2C1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5491B1-C4A9-9F47-98C2-F05075F88C86}" type="datetimeFigureOut">
              <a:rPr lang="de-DE" smtClean="0"/>
              <a:t>09.08.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A3286C4-44EA-B903-99C9-E94B7B3DE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B15CCAE-0412-B60C-60AB-CD7230059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B8393-E09B-8148-A1F6-08E0FC6F3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88672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4733A5A-CD46-97D0-6104-D64D925DEB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989B3D1-AE3D-1A11-CAEF-A868235EDF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DA2ABC3-D3EC-AA07-7E9A-7E0831522F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C97B949E-3EFE-385F-4A27-C628733677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34A6C2C5-4BFC-BA96-7919-74FB018386C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EA71D0C4-3E80-BDC6-2EDB-88B21BB443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5491B1-C4A9-9F47-98C2-F05075F88C86}" type="datetimeFigureOut">
              <a:rPr lang="de-DE" smtClean="0"/>
              <a:t>09.08.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BF00C307-5905-CC75-2D6F-3DE26B620E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566B8044-1C6B-1DDD-EDE7-ED9655E7E7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B8393-E09B-8148-A1F6-08E0FC6F3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3548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73F2876-FD46-B969-E2A5-C635623EB3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492DE61F-C15A-59D1-3CF0-98491B883B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5491B1-C4A9-9F47-98C2-F05075F88C86}" type="datetimeFigureOut">
              <a:rPr lang="de-DE" smtClean="0"/>
              <a:t>09.08.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A2AAF42-D4C3-0015-F6E1-1905B76B57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DABF19E3-F946-479D-DDA5-00F631B8CE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B8393-E09B-8148-A1F6-08E0FC6F3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5009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C05C604C-6BAC-F652-918F-F0054C3EB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5491B1-C4A9-9F47-98C2-F05075F88C86}" type="datetimeFigureOut">
              <a:rPr lang="de-DE" smtClean="0"/>
              <a:t>09.08.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975970C6-A38A-D1D3-004E-8C002A17E0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79492804-E0F8-FF8D-0860-08645BE9A8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B8393-E09B-8148-A1F6-08E0FC6F3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904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3044A58-336D-BFA1-73C2-6E92ED52E8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BDC6B55-68BE-2CCB-6193-ECDA62FC29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A80FC9D7-3442-8CB3-F0C6-F4EA2B5D76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8E75878-30BA-0E16-D3A4-66ADF5AF61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5491B1-C4A9-9F47-98C2-F05075F88C86}" type="datetimeFigureOut">
              <a:rPr lang="de-DE" smtClean="0"/>
              <a:t>09.08.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700348C-AB48-7056-D2D2-86E3EB89E0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2BBE0F7-A30C-AF68-EDA9-DF4DF57522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B8393-E09B-8148-A1F6-08E0FC6F3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2436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A99C9FA-7A52-3067-A9B7-3AA1477B28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106E2A22-D778-9189-F975-F0CA1C67B1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AC8EC1F-95E0-AD17-8FC3-085E6D4FCC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F8B62F0-D0BE-77F3-776B-865A24AC7D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5491B1-C4A9-9F47-98C2-F05075F88C86}" type="datetimeFigureOut">
              <a:rPr lang="de-DE" smtClean="0"/>
              <a:t>09.08.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D2C366D-7C89-43F2-F4C2-C6D7D0383D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D4ACB91-EDC1-9A06-0352-DD26F00D6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B8393-E09B-8148-A1F6-08E0FC6F3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2988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E114E3AD-7667-B4CF-B791-F5D5B5C874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4536009-9637-BC1C-CE2C-6C99F1A9E0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DB9D048-577A-FEE7-D952-E527D3A346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5491B1-C4A9-9F47-98C2-F05075F88C86}" type="datetimeFigureOut">
              <a:rPr lang="de-DE" smtClean="0"/>
              <a:t>09.08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5D25A06-979B-DD54-55D6-A53105E4AD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B8EB7CE-B57C-8C80-038E-F961856257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9B8393-E09B-8148-A1F6-08E0FC6F33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9734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0693E73F-F3C5-8021-A821-8D47B1CD541D}"/>
              </a:ext>
            </a:extLst>
          </p:cNvPr>
          <p:cNvSpPr txBox="1"/>
          <p:nvPr/>
        </p:nvSpPr>
        <p:spPr>
          <a:xfrm>
            <a:off x="1" y="863552"/>
            <a:ext cx="25261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COVIP Trial</a:t>
            </a:r>
          </a:p>
          <a:p>
            <a:pPr algn="ctr"/>
            <a:r>
              <a:rPr lang="de-DE" dirty="0"/>
              <a:t>n= </a:t>
            </a:r>
            <a:r>
              <a:rPr lang="en-US" dirty="0"/>
              <a:t>3,957 </a:t>
            </a:r>
            <a:endParaRPr lang="de-DE" dirty="0"/>
          </a:p>
        </p:txBody>
      </p:sp>
      <p:sp>
        <p:nvSpPr>
          <p:cNvPr id="5" name="Pfeil nach unten 4">
            <a:extLst>
              <a:ext uri="{FF2B5EF4-FFF2-40B4-BE49-F238E27FC236}">
                <a16:creationId xmlns:a16="http://schemas.microsoft.com/office/drawing/2014/main" id="{5E70E649-5ABB-5068-7586-B8DF32EE48E6}"/>
              </a:ext>
            </a:extLst>
          </p:cNvPr>
          <p:cNvSpPr/>
          <p:nvPr/>
        </p:nvSpPr>
        <p:spPr>
          <a:xfrm>
            <a:off x="847930" y="1786758"/>
            <a:ext cx="830317" cy="1019503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E2651D44-0545-6E9B-6212-28F01D79A2D2}"/>
              </a:ext>
            </a:extLst>
          </p:cNvPr>
          <p:cNvSpPr txBox="1"/>
          <p:nvPr/>
        </p:nvSpPr>
        <p:spPr>
          <a:xfrm>
            <a:off x="0" y="3083136"/>
            <a:ext cx="25261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/>
              <a:t>Patients</a:t>
            </a:r>
            <a:r>
              <a:rPr lang="de-DE" dirty="0"/>
              <a:t> in THS </a:t>
            </a:r>
            <a:r>
              <a:rPr lang="de-DE" dirty="0" err="1"/>
              <a:t>or</a:t>
            </a:r>
            <a:r>
              <a:rPr lang="de-DE" dirty="0"/>
              <a:t> SHI</a:t>
            </a:r>
          </a:p>
          <a:p>
            <a:pPr algn="ctr"/>
            <a:r>
              <a:rPr lang="de-DE" dirty="0"/>
              <a:t>n= </a:t>
            </a:r>
            <a:r>
              <a:rPr lang="en-US" dirty="0"/>
              <a:t>3,118 </a:t>
            </a:r>
            <a:endParaRPr lang="de-DE" dirty="0"/>
          </a:p>
        </p:txBody>
      </p:sp>
      <p:sp>
        <p:nvSpPr>
          <p:cNvPr id="7" name="Pfeil nach unten 6">
            <a:extLst>
              <a:ext uri="{FF2B5EF4-FFF2-40B4-BE49-F238E27FC236}">
                <a16:creationId xmlns:a16="http://schemas.microsoft.com/office/drawing/2014/main" id="{3B6B80B6-156E-85E8-A42F-311213362CF8}"/>
              </a:ext>
            </a:extLst>
          </p:cNvPr>
          <p:cNvSpPr/>
          <p:nvPr/>
        </p:nvSpPr>
        <p:spPr>
          <a:xfrm>
            <a:off x="847930" y="3757449"/>
            <a:ext cx="830317" cy="1019503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4FBBAF57-12A4-9264-C288-7DC088D8E92A}"/>
              </a:ext>
            </a:extLst>
          </p:cNvPr>
          <p:cNvSpPr txBox="1"/>
          <p:nvPr/>
        </p:nvSpPr>
        <p:spPr>
          <a:xfrm>
            <a:off x="0" y="5053827"/>
            <a:ext cx="25261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Study </a:t>
            </a:r>
            <a:r>
              <a:rPr lang="de-DE" dirty="0" err="1"/>
              <a:t>cohort</a:t>
            </a:r>
            <a:endParaRPr lang="de-DE" dirty="0"/>
          </a:p>
          <a:p>
            <a:pPr algn="ctr"/>
            <a:r>
              <a:rPr lang="de-DE" dirty="0"/>
              <a:t>n= </a:t>
            </a:r>
            <a:r>
              <a:rPr lang="en-US" dirty="0"/>
              <a:t>2,406 </a:t>
            </a:r>
            <a:endParaRPr lang="de-DE" dirty="0"/>
          </a:p>
        </p:txBody>
      </p:sp>
      <p:sp>
        <p:nvSpPr>
          <p:cNvPr id="9" name="Pfeil nach rechts 8">
            <a:extLst>
              <a:ext uri="{FF2B5EF4-FFF2-40B4-BE49-F238E27FC236}">
                <a16:creationId xmlns:a16="http://schemas.microsoft.com/office/drawing/2014/main" id="{E88AB589-0160-CE8B-D864-AC00E491A07A}"/>
              </a:ext>
            </a:extLst>
          </p:cNvPr>
          <p:cNvSpPr/>
          <p:nvPr/>
        </p:nvSpPr>
        <p:spPr>
          <a:xfrm>
            <a:off x="2445502" y="821510"/>
            <a:ext cx="1792014" cy="68317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2256BDE1-A1E9-5B39-6AAA-25A13BEA4CF4}"/>
              </a:ext>
            </a:extLst>
          </p:cNvPr>
          <p:cNvSpPr txBox="1"/>
          <p:nvPr/>
        </p:nvSpPr>
        <p:spPr>
          <a:xfrm>
            <a:off x="4484509" y="880508"/>
            <a:ext cx="284489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/>
              <a:t>Patients</a:t>
            </a:r>
            <a:r>
              <a:rPr lang="de-DE" dirty="0"/>
              <a:t> not in THS </a:t>
            </a:r>
            <a:r>
              <a:rPr lang="de-DE" dirty="0" err="1"/>
              <a:t>or</a:t>
            </a:r>
            <a:r>
              <a:rPr lang="de-DE" dirty="0"/>
              <a:t> SHI</a:t>
            </a:r>
          </a:p>
          <a:p>
            <a:pPr algn="ctr"/>
            <a:r>
              <a:rPr lang="de-DE" dirty="0"/>
              <a:t>n= </a:t>
            </a:r>
            <a:r>
              <a:rPr lang="en-US" dirty="0"/>
              <a:t>839 </a:t>
            </a:r>
            <a:endParaRPr lang="de-DE" dirty="0"/>
          </a:p>
        </p:txBody>
      </p:sp>
      <p:sp>
        <p:nvSpPr>
          <p:cNvPr id="12" name="Pfeil nach rechts 11">
            <a:extLst>
              <a:ext uri="{FF2B5EF4-FFF2-40B4-BE49-F238E27FC236}">
                <a16:creationId xmlns:a16="http://schemas.microsoft.com/office/drawing/2014/main" id="{E9D36537-57AB-D0FB-5693-558ADCE981D4}"/>
              </a:ext>
            </a:extLst>
          </p:cNvPr>
          <p:cNvSpPr/>
          <p:nvPr/>
        </p:nvSpPr>
        <p:spPr>
          <a:xfrm>
            <a:off x="2445502" y="3016576"/>
            <a:ext cx="2039007" cy="683172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B3501AC2-7979-F1C8-AF06-C031725F2698}"/>
              </a:ext>
            </a:extLst>
          </p:cNvPr>
          <p:cNvSpPr txBox="1"/>
          <p:nvPr/>
        </p:nvSpPr>
        <p:spPr>
          <a:xfrm>
            <a:off x="4484509" y="3051712"/>
            <a:ext cx="2844894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err="1"/>
              <a:t>Patients</a:t>
            </a:r>
            <a:r>
              <a:rPr lang="de-DE" dirty="0"/>
              <a:t> </a:t>
            </a:r>
            <a:r>
              <a:rPr lang="de-AT" dirty="0" err="1"/>
              <a:t>with</a:t>
            </a:r>
            <a:r>
              <a:rPr lang="de-AT" dirty="0"/>
              <a:t> </a:t>
            </a:r>
            <a:r>
              <a:rPr lang="de-AT" dirty="0" err="1"/>
              <a:t>missing</a:t>
            </a:r>
            <a:r>
              <a:rPr lang="de-AT" dirty="0"/>
              <a:t> </a:t>
            </a:r>
            <a:r>
              <a:rPr lang="de-AT" dirty="0" err="1"/>
              <a:t>values</a:t>
            </a:r>
            <a:r>
              <a:rPr lang="de-AT" dirty="0"/>
              <a:t> on </a:t>
            </a:r>
            <a:r>
              <a:rPr lang="de-AT" dirty="0" err="1"/>
              <a:t>either</a:t>
            </a:r>
            <a:r>
              <a:rPr lang="de-AT" dirty="0"/>
              <a:t>/</a:t>
            </a:r>
            <a:r>
              <a:rPr lang="de-AT" dirty="0" err="1"/>
              <a:t>or</a:t>
            </a:r>
            <a:r>
              <a:rPr lang="de-AT" dirty="0"/>
              <a:t> </a:t>
            </a:r>
            <a:r>
              <a:rPr lang="en-GB" dirty="0"/>
              <a:t>age, sex, clinical frailty score (CFS) frailty score, sequential organ failure assessment (SOFA) score and 30-day-mortality</a:t>
            </a:r>
            <a:r>
              <a:rPr lang="de-AT" dirty="0">
                <a:effectLst/>
              </a:rPr>
              <a:t> </a:t>
            </a:r>
          </a:p>
          <a:p>
            <a:pPr algn="ctr"/>
            <a:r>
              <a:rPr lang="de-AT" dirty="0"/>
              <a:t>n=712</a:t>
            </a:r>
            <a:endParaRPr lang="de-DE" dirty="0"/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031E02B9-F960-B7C0-E901-2A3E6F29038E}"/>
              </a:ext>
            </a:extLst>
          </p:cNvPr>
          <p:cNvSpPr txBox="1"/>
          <p:nvPr/>
        </p:nvSpPr>
        <p:spPr>
          <a:xfrm>
            <a:off x="0" y="52551"/>
            <a:ext cx="28448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b="1" dirty="0" err="1"/>
              <a:t>Supplementary</a:t>
            </a:r>
            <a:r>
              <a:rPr lang="de-AT" b="1" dirty="0"/>
              <a:t> Figure 1</a:t>
            </a:r>
            <a:endParaRPr lang="de-DE" b="1" dirty="0"/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61FE0903-5963-7C49-B796-694FAFB076AB}"/>
              </a:ext>
            </a:extLst>
          </p:cNvPr>
          <p:cNvSpPr txBox="1"/>
          <p:nvPr/>
        </p:nvSpPr>
        <p:spPr>
          <a:xfrm>
            <a:off x="128588" y="6086475"/>
            <a:ext cx="94154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Legend: </a:t>
            </a:r>
            <a:r>
              <a:rPr lang="de-DE" dirty="0" err="1"/>
              <a:t>Flowchart</a:t>
            </a:r>
            <a:r>
              <a:rPr lang="de-DE" dirty="0"/>
              <a:t> of </a:t>
            </a:r>
            <a:r>
              <a:rPr lang="de-DE" dirty="0" err="1"/>
              <a:t>patient</a:t>
            </a:r>
            <a:r>
              <a:rPr lang="de-DE" dirty="0"/>
              <a:t> </a:t>
            </a:r>
            <a:r>
              <a:rPr lang="de-DE" dirty="0" err="1"/>
              <a:t>inclusion</a:t>
            </a:r>
            <a:r>
              <a:rPr lang="de-DE" dirty="0"/>
              <a:t> and </a:t>
            </a:r>
            <a:r>
              <a:rPr lang="de-DE" dirty="0" err="1"/>
              <a:t>exclusion</a:t>
            </a:r>
            <a:r>
              <a:rPr lang="de-DE" dirty="0"/>
              <a:t>. </a:t>
            </a:r>
            <a:r>
              <a:rPr lang="de-DE" i="1" dirty="0" err="1"/>
              <a:t>Abbreviations</a:t>
            </a:r>
            <a:r>
              <a:rPr lang="de-DE" i="1" dirty="0"/>
              <a:t>: COVIP: COVID-19 in </a:t>
            </a:r>
            <a:r>
              <a:rPr lang="de-DE" i="1" dirty="0" err="1"/>
              <a:t>very</a:t>
            </a:r>
            <a:r>
              <a:rPr lang="de-DE" i="1" dirty="0"/>
              <a:t> </a:t>
            </a:r>
            <a:r>
              <a:rPr lang="de-DE" i="1" dirty="0" err="1"/>
              <a:t>old</a:t>
            </a:r>
            <a:r>
              <a:rPr lang="de-DE" i="1" dirty="0"/>
              <a:t> intensive care </a:t>
            </a:r>
            <a:r>
              <a:rPr lang="de-DE" i="1" dirty="0" err="1"/>
              <a:t>patients</a:t>
            </a:r>
            <a:r>
              <a:rPr lang="de-DE" i="1" dirty="0"/>
              <a:t>; SHI: </a:t>
            </a:r>
            <a:r>
              <a:rPr lang="de-DE" i="1" dirty="0" err="1"/>
              <a:t>social</a:t>
            </a:r>
            <a:r>
              <a:rPr lang="de-DE" i="1" dirty="0"/>
              <a:t> </a:t>
            </a:r>
            <a:r>
              <a:rPr lang="de-DE" i="1" dirty="0" err="1"/>
              <a:t>health</a:t>
            </a:r>
            <a:r>
              <a:rPr lang="de-DE" i="1" dirty="0"/>
              <a:t> </a:t>
            </a:r>
            <a:r>
              <a:rPr lang="de-DE" i="1" dirty="0" err="1"/>
              <a:t>insurance</a:t>
            </a:r>
            <a:r>
              <a:rPr lang="de-DE" i="1" dirty="0"/>
              <a:t> </a:t>
            </a:r>
            <a:r>
              <a:rPr lang="de-DE" i="1" dirty="0" err="1"/>
              <a:t>system</a:t>
            </a:r>
            <a:r>
              <a:rPr lang="de-DE" i="1" dirty="0"/>
              <a:t>; THS: tax-</a:t>
            </a:r>
            <a:r>
              <a:rPr lang="de-DE" i="1" dirty="0" err="1"/>
              <a:t>based</a:t>
            </a:r>
            <a:r>
              <a:rPr lang="de-DE" i="1" dirty="0"/>
              <a:t> </a:t>
            </a:r>
            <a:r>
              <a:rPr lang="de-DE" i="1" dirty="0" err="1"/>
              <a:t>health</a:t>
            </a:r>
            <a:r>
              <a:rPr lang="de-DE" i="1" dirty="0"/>
              <a:t> care </a:t>
            </a:r>
            <a:r>
              <a:rPr lang="de-DE" i="1" dirty="0" err="1"/>
              <a:t>system</a:t>
            </a:r>
            <a:r>
              <a:rPr lang="de-DE" i="1" dirty="0"/>
              <a:t>;</a:t>
            </a:r>
          </a:p>
        </p:txBody>
      </p:sp>
    </p:spTree>
    <p:extLst>
      <p:ext uri="{BB962C8B-B14F-4D97-AF65-F5344CB8AC3E}">
        <p14:creationId xmlns:p14="http://schemas.microsoft.com/office/powerpoint/2010/main" val="3536862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9</Words>
  <Application>Microsoft Macintosh PowerPoint</Application>
  <PresentationFormat>Breitbild</PresentationFormat>
  <Paragraphs>1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rnhard Wernly</dc:creator>
  <cp:lastModifiedBy>Microsoft Office User</cp:lastModifiedBy>
  <cp:revision>7</cp:revision>
  <dcterms:created xsi:type="dcterms:W3CDTF">2022-07-26T20:20:55Z</dcterms:created>
  <dcterms:modified xsi:type="dcterms:W3CDTF">2022-08-09T16:08:25Z</dcterms:modified>
</cp:coreProperties>
</file>